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AFDED2D-A70F-7AF7-97D1-183DFD8B3FD0}" name="Thornton, Laura Marie" initials="LT" userId="S::lmthornt@ad.unc.edu::3911c269-5083-4620-959f-c6fd29770d6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5165" autoAdjust="0"/>
  </p:normalViewPr>
  <p:slideViewPr>
    <p:cSldViewPr snapToGrid="0">
      <p:cViewPr varScale="1">
        <p:scale>
          <a:sx n="81" d="100"/>
          <a:sy n="81" d="100"/>
        </p:scale>
        <p:origin x="6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522020-B0F7-4050-835F-A3BC7D82426A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2AAF2A-F105-42FA-B58E-A0F73B7F8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324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C9EC2-7C7C-407F-B91C-DB9BF22396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284A0F-82DA-441A-BC47-4F8D8E9143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60D535-AA82-4F9A-81F6-2479CDA64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9093FF-2C80-459A-B40B-A15B93535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D91FB5-6785-487A-88EB-F841D7C13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929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036B6-008E-422C-9D7F-6DCFD132C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60634B-37D5-462E-A379-89FA970124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EA5C3F-A520-4088-9A68-1A6FD25B8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D65251-C527-47F4-AB6E-4F1D4DBE8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F4F70C-B68A-403F-9402-49187FE18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016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4579C2-1D89-4B0A-9134-8537EBE97A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2139B9-A791-4EE7-B4CD-E8776CF5B9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8BE2BA-6DF9-4967-916F-16A68794E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458DB1-5533-40C4-A84F-80E662DF7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92EC10-CEA6-4687-BC33-1AFD2EF20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1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63745-A9DE-4098-811A-F3F5670838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3BB87E-B942-49C3-9549-323291E576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95D12-D2AC-4D93-8D05-1B6F7D672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B83D55-BCAE-47D1-8E12-E57C816B1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E23F85-857B-4DF2-A9C3-E52772303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431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7D1060-7E58-4377-86B4-90BE8FBD4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4EB9B1-5984-42F8-82DE-3628ED3407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FEA1D-B1AC-4BED-B3A0-30F063AAF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A67A88-9C09-4C51-BAB4-CF27B980E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3B855E-3C9F-4B35-AA03-9E6A95DBB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235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099B9-C292-4625-81C1-1D399DCA9A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881F42-9C1F-430B-9EAF-6EB39A4BAF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6B1A1B-2C85-4720-94F1-A6EB07313F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A97EA5-90D5-4588-8725-84E1E23A1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21429D-6362-4E60-870E-0788A521D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E9900B-1376-497C-AC65-943C8D9FA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384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AB7DF6-2835-49B6-B905-688529B23E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45B807-0F9E-4B70-BF80-5F39148B2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2CEF56-3B80-4305-9062-34DC727E5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83FFA8-5D07-4E47-8B67-BE62070194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30A46D-9A01-4B50-9942-33849A2B96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AA9F70-9A0C-4CDD-890C-B300BB3FC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E6C154-699E-48F0-B6A2-B009B94B3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ADB46F-CB9D-4D45-9893-502ACB706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35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C16C96-4D77-41EC-A66D-EA45539D2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37EA1E-240A-416E-AECF-CB8354EC4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314E62-1EC1-4BA7-B39C-1198CF4E0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EAF0A0-6B17-4D13-AE87-E18BBA5D2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430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B3DB69-556A-4C04-8355-71A694E63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88FDC1-FABD-4DC6-92C8-BB9BA1761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7E6B71-0C69-4774-9434-2F9F82E1B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412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808EF-5E6B-488F-BC2C-59B8748A9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C45DDC-104C-4BEB-A2CC-11AE9A8071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87A72D-1B4E-4FB0-AD8F-56E0EB3087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5693F2-BDF2-46ED-BC83-4D1149DB6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CC0D1B-65EC-4D6E-95C9-59E645F91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144F96-EC75-4CCB-A9DA-8CF6EB3BF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240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7E074-92B1-43A3-ACC2-BD3414A9B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8E6D0D-2583-4867-8253-51B434B5A5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3789D5-444B-4C1E-A373-FCE88E0A1B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2193DF-B06F-4FFF-B3D6-FFE49D6A9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75F2CC-4E15-4775-BCD9-FEE512B63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BC5AEF-026D-4875-A6A9-013782F4A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094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EF40C6-EFE8-4956-8DA1-118BD306D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10FB89-D0A5-40EC-A9C4-1246C2AA68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711D0C-C16E-4DE3-9F09-C80A4E8B37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EE929-92DE-4A10-9CC0-8E0064057090}" type="datetimeFigureOut">
              <a:rPr lang="en-US" smtClean="0"/>
              <a:t>12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1728A6-41A7-4CCB-B070-4C58BEAF75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0FF051-7884-4D71-B712-47CADE87DF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2BA06-7F60-48DC-8C5A-8135BDD27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246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7ABE106-ADC7-4F54-A653-CDF7D7C82D83}"/>
              </a:ext>
            </a:extLst>
          </p:cNvPr>
          <p:cNvSpPr txBox="1"/>
          <p:nvPr/>
        </p:nvSpPr>
        <p:spPr>
          <a:xfrm>
            <a:off x="2790334" y="66675"/>
            <a:ext cx="2343641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tarting Trays </a:t>
            </a:r>
            <a:r>
              <a:rPr lang="en-US" dirty="0"/>
              <a:t>N=11,741</a:t>
            </a:r>
          </a:p>
          <a:p>
            <a:pPr algn="ctr"/>
            <a:r>
              <a:rPr lang="en-US" dirty="0"/>
              <a:t>(includes double rated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95593EA-CC59-4216-81F7-91DE585106EE}"/>
              </a:ext>
            </a:extLst>
          </p:cNvPr>
          <p:cNvSpPr txBox="1"/>
          <p:nvPr/>
        </p:nvSpPr>
        <p:spPr>
          <a:xfrm>
            <a:off x="1824033" y="5304353"/>
            <a:ext cx="4295775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nalysis Sample </a:t>
            </a:r>
          </a:p>
          <a:p>
            <a:pPr algn="ctr"/>
            <a:r>
              <a:rPr lang="en-US" dirty="0"/>
              <a:t>N=6,623</a:t>
            </a:r>
          </a:p>
          <a:p>
            <a:pPr algn="ctr"/>
            <a:r>
              <a:rPr lang="en-US" dirty="0"/>
              <a:t>Salad Bar (n=3,273) Control (n=3,350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8056B9-C09D-4827-868D-906A96351166}"/>
              </a:ext>
            </a:extLst>
          </p:cNvPr>
          <p:cNvSpPr txBox="1"/>
          <p:nvPr/>
        </p:nvSpPr>
        <p:spPr>
          <a:xfrm>
            <a:off x="5476875" y="990005"/>
            <a:ext cx="320039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No matched pre- or post-consumption image</a:t>
            </a:r>
          </a:p>
          <a:p>
            <a:r>
              <a:rPr lang="en-US" dirty="0"/>
              <a:t>(n=1,576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10F6DCC-4E4E-4257-8411-30C296A3260F}"/>
              </a:ext>
            </a:extLst>
          </p:cNvPr>
          <p:cNvSpPr txBox="1"/>
          <p:nvPr/>
        </p:nvSpPr>
        <p:spPr>
          <a:xfrm>
            <a:off x="5476874" y="2021085"/>
            <a:ext cx="320039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No post-data collection due to COVID-19 school closings (n=812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B88B288-94A0-43EE-9BB1-2D71BAEAC76D}"/>
              </a:ext>
            </a:extLst>
          </p:cNvPr>
          <p:cNvSpPr txBox="1"/>
          <p:nvPr/>
        </p:nvSpPr>
        <p:spPr>
          <a:xfrm>
            <a:off x="5476872" y="3056930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Fruit or vegetable could not be rated (n=519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E60B37-26C9-423D-A8AD-BDA7756E2FBC}"/>
              </a:ext>
            </a:extLst>
          </p:cNvPr>
          <p:cNvSpPr txBox="1"/>
          <p:nvPr/>
        </p:nvSpPr>
        <p:spPr>
          <a:xfrm>
            <a:off x="5476872" y="3813928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Grade not indicated or not matched between pairs (n=575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F40B73F-4466-4689-86CE-005998770958}"/>
              </a:ext>
            </a:extLst>
          </p:cNvPr>
          <p:cNvSpPr txBox="1"/>
          <p:nvPr/>
        </p:nvSpPr>
        <p:spPr>
          <a:xfrm>
            <a:off x="5476874" y="4572774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Removed double rated tray (n=1,636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C65AD6E-9296-441E-85BC-FD5FA5DBB197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>
            <a:off x="3962155" y="990005"/>
            <a:ext cx="9766" cy="431434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0049E27-ED82-44E7-B8EA-B4DE1D5CAC7C}"/>
              </a:ext>
            </a:extLst>
          </p:cNvPr>
          <p:cNvCxnSpPr/>
          <p:nvPr/>
        </p:nvCxnSpPr>
        <p:spPr>
          <a:xfrm>
            <a:off x="3962400" y="1494235"/>
            <a:ext cx="15144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618765E2-2092-4D18-862C-0D8410A73367}"/>
              </a:ext>
            </a:extLst>
          </p:cNvPr>
          <p:cNvSpPr txBox="1"/>
          <p:nvPr/>
        </p:nvSpPr>
        <p:spPr>
          <a:xfrm>
            <a:off x="5348285" y="630317"/>
            <a:ext cx="3681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Number and Reasons for Exclusion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D47D26B-E0D6-44DC-86A7-2DF1CEAA86F6}"/>
              </a:ext>
            </a:extLst>
          </p:cNvPr>
          <p:cNvCxnSpPr/>
          <p:nvPr/>
        </p:nvCxnSpPr>
        <p:spPr>
          <a:xfrm>
            <a:off x="3962396" y="2513410"/>
            <a:ext cx="15144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52A0A13-D972-4AF6-93C4-8A5A7BBF58EA}"/>
              </a:ext>
            </a:extLst>
          </p:cNvPr>
          <p:cNvCxnSpPr/>
          <p:nvPr/>
        </p:nvCxnSpPr>
        <p:spPr>
          <a:xfrm>
            <a:off x="3962396" y="3408760"/>
            <a:ext cx="15144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3AC76F1-BD93-4F84-B838-76131FDF8E13}"/>
              </a:ext>
            </a:extLst>
          </p:cNvPr>
          <p:cNvCxnSpPr/>
          <p:nvPr/>
        </p:nvCxnSpPr>
        <p:spPr>
          <a:xfrm>
            <a:off x="3962396" y="4199335"/>
            <a:ext cx="15144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5C6F9F2-3963-4CD6-A599-EE1685E1D3F9}"/>
              </a:ext>
            </a:extLst>
          </p:cNvPr>
          <p:cNvCxnSpPr/>
          <p:nvPr/>
        </p:nvCxnSpPr>
        <p:spPr>
          <a:xfrm>
            <a:off x="3962400" y="4866085"/>
            <a:ext cx="151447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3242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1</TotalTime>
  <Words>91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nie Bean</dc:creator>
  <cp:lastModifiedBy>Melanie Bean</cp:lastModifiedBy>
  <cp:revision>87</cp:revision>
  <dcterms:created xsi:type="dcterms:W3CDTF">2024-02-22T17:02:42Z</dcterms:created>
  <dcterms:modified xsi:type="dcterms:W3CDTF">2024-12-08T16:04:57Z</dcterms:modified>
</cp:coreProperties>
</file>